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1426" y="53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174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795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9574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1364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760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551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626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607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6283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312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765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004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519237"/>
            <a:ext cx="8919264" cy="4119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ttangolo 4"/>
          <p:cNvSpPr/>
          <p:nvPr/>
        </p:nvSpPr>
        <p:spPr>
          <a:xfrm>
            <a:off x="1828800" y="1600200"/>
            <a:ext cx="1040926" cy="345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2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IC L-Asp</a:t>
            </a:r>
            <a:endParaRPr lang="en-US" sz="12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ttangolo 5"/>
          <p:cNvSpPr/>
          <p:nvPr/>
        </p:nvSpPr>
        <p:spPr>
          <a:xfrm>
            <a:off x="2514600" y="2438400"/>
            <a:ext cx="964726" cy="345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2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IC D-Asp</a:t>
            </a:r>
            <a:endParaRPr lang="en-US" sz="12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ttangolo 6"/>
          <p:cNvSpPr/>
          <p:nvPr/>
        </p:nvSpPr>
        <p:spPr>
          <a:xfrm>
            <a:off x="7386282" y="1466850"/>
            <a:ext cx="1040926" cy="345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2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IC NMDA</a:t>
            </a:r>
            <a:endParaRPr lang="en-US" sz="12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ttangolo 7"/>
          <p:cNvSpPr/>
          <p:nvPr/>
        </p:nvSpPr>
        <p:spPr>
          <a:xfrm>
            <a:off x="5715000" y="2888775"/>
            <a:ext cx="1600200" cy="54022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cursor </a:t>
            </a:r>
            <a:r>
              <a:rPr lang="it-IT" sz="1000" b="1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on</a:t>
            </a:r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/z </a:t>
            </a:r>
            <a:r>
              <a:rPr lang="en-US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8.0</a:t>
            </a:r>
          </a:p>
          <a:p>
            <a:pPr algn="ctr"/>
            <a:r>
              <a:rPr lang="it-IT" sz="1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duct </a:t>
            </a:r>
            <a:r>
              <a:rPr lang="it-IT" sz="1000" b="1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on</a:t>
            </a:r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/z </a:t>
            </a:r>
            <a:r>
              <a:rPr lang="en-US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8.0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sz="1000" b="1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</a:t>
            </a:r>
            <a:endParaRPr lang="en-US" sz="10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Connettore 2 8"/>
          <p:cNvCxnSpPr/>
          <p:nvPr/>
        </p:nvCxnSpPr>
        <p:spPr>
          <a:xfrm flipH="1">
            <a:off x="2907127" y="3174234"/>
            <a:ext cx="369200" cy="240054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nettore 2 9"/>
          <p:cNvCxnSpPr/>
          <p:nvPr/>
        </p:nvCxnSpPr>
        <p:spPr>
          <a:xfrm flipH="1">
            <a:off x="2950060" y="3971347"/>
            <a:ext cx="369200" cy="240054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ttangolo 10"/>
          <p:cNvSpPr/>
          <p:nvPr/>
        </p:nvSpPr>
        <p:spPr>
          <a:xfrm>
            <a:off x="485775" y="2418701"/>
            <a:ext cx="1540633" cy="5062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cursor </a:t>
            </a:r>
            <a:r>
              <a:rPr lang="it-IT" sz="1000" b="1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on</a:t>
            </a:r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/z </a:t>
            </a:r>
            <a:r>
              <a:rPr lang="en-US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4.0</a:t>
            </a:r>
          </a:p>
          <a:p>
            <a:pPr algn="ctr"/>
            <a:r>
              <a:rPr lang="it-IT" sz="1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duct </a:t>
            </a:r>
            <a:r>
              <a:rPr lang="it-IT" sz="1000" b="1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on</a:t>
            </a:r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/z </a:t>
            </a:r>
            <a:r>
              <a:rPr lang="en-US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6.0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sz="1000" b="1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sz="10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ttangolo 11"/>
          <p:cNvSpPr/>
          <p:nvPr/>
        </p:nvSpPr>
        <p:spPr>
          <a:xfrm>
            <a:off x="3224479" y="2919402"/>
            <a:ext cx="1481067" cy="5095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cursor </a:t>
            </a:r>
            <a:r>
              <a:rPr lang="it-IT" sz="1000" b="1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on</a:t>
            </a:r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/z </a:t>
            </a:r>
            <a:r>
              <a:rPr lang="en-US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4.0</a:t>
            </a:r>
          </a:p>
          <a:p>
            <a:pPr algn="ctr"/>
            <a:r>
              <a:rPr lang="it-IT" sz="1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duct </a:t>
            </a:r>
            <a:r>
              <a:rPr lang="it-IT" sz="1000" b="1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on</a:t>
            </a:r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/z </a:t>
            </a:r>
            <a:r>
              <a:rPr lang="en-US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6.0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sz="1000" b="1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sz="10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ttangolo 12"/>
          <p:cNvSpPr/>
          <p:nvPr/>
        </p:nvSpPr>
        <p:spPr>
          <a:xfrm>
            <a:off x="457200" y="3760953"/>
            <a:ext cx="1540633" cy="5062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cursor </a:t>
            </a:r>
            <a:r>
              <a:rPr lang="it-IT" sz="1000" b="1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on</a:t>
            </a:r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/z </a:t>
            </a:r>
            <a:r>
              <a:rPr lang="en-US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4.0</a:t>
            </a:r>
          </a:p>
          <a:p>
            <a:pPr algn="ctr"/>
            <a:r>
              <a:rPr lang="it-IT" sz="1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duct </a:t>
            </a:r>
            <a:r>
              <a:rPr lang="it-IT" sz="1000" b="1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on</a:t>
            </a:r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/z </a:t>
            </a:r>
            <a:r>
              <a:rPr lang="en-US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8.0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sz="1000" b="1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sz="10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ttangolo 13"/>
          <p:cNvSpPr/>
          <p:nvPr/>
        </p:nvSpPr>
        <p:spPr>
          <a:xfrm>
            <a:off x="3290980" y="3633421"/>
            <a:ext cx="1540633" cy="5062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cursor </a:t>
            </a:r>
            <a:r>
              <a:rPr lang="it-IT" sz="1000" b="1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on</a:t>
            </a:r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/z </a:t>
            </a:r>
            <a:r>
              <a:rPr lang="en-US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4.0</a:t>
            </a:r>
          </a:p>
          <a:p>
            <a:pPr algn="ctr"/>
            <a:r>
              <a:rPr lang="it-IT" sz="1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duct </a:t>
            </a:r>
            <a:r>
              <a:rPr lang="it-IT" sz="1000" b="1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on</a:t>
            </a:r>
            <a:r>
              <a:rPr lang="it-IT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/z </a:t>
            </a:r>
            <a:r>
              <a:rPr lang="en-US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8.0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sz="1000" b="1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sz="10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CasellaDiTesto 3"/>
          <p:cNvSpPr txBox="1"/>
          <p:nvPr/>
        </p:nvSpPr>
        <p:spPr>
          <a:xfrm>
            <a:off x="0" y="171110"/>
            <a:ext cx="90678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1 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MSMS analysis in MRM mode of </a:t>
            </a:r>
            <a:r>
              <a:rPr lang="en-GB" cap="small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sp, </a:t>
            </a:r>
            <a:r>
              <a:rPr lang="en-GB" cap="small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sp and NMDA mixture. The TIC chromatogram and the specific MRM transitions for each </a:t>
            </a:r>
            <a:r>
              <a:rPr lang="en-GB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te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indicated.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1910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6</TotalTime>
  <Words>81</Words>
  <Application>Microsoft Office PowerPoint</Application>
  <PresentationFormat>Presentazione su schermo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lient3</dc:creator>
  <cp:lastModifiedBy>Gabriella Pinto</cp:lastModifiedBy>
  <cp:revision>20</cp:revision>
  <dcterms:created xsi:type="dcterms:W3CDTF">2017-01-19T15:56:15Z</dcterms:created>
  <dcterms:modified xsi:type="dcterms:W3CDTF">2017-02-14T17:11:38Z</dcterms:modified>
</cp:coreProperties>
</file>